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658" y="1109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3268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055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6308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2548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5794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7881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5487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1619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7202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9959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9124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092AAE-721E-4CD9-865C-9BBA7240A61C}" type="datetimeFigureOut">
              <a:rPr lang="zh-CN" altLang="en-US" smtClean="0"/>
              <a:t>2024/10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F03A5-3364-4C26-A8BF-C846D065CB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4905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0800000">
            <a:off x="-19189" y="895741"/>
            <a:ext cx="461665" cy="15121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nong No.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 rot="10800000">
            <a:off x="-60752" y="3493638"/>
            <a:ext cx="461665" cy="136815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inhuang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7" y="711954"/>
            <a:ext cx="2520280" cy="1879742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7" y="3284984"/>
            <a:ext cx="2592287" cy="1933447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66984" y="111446"/>
            <a:ext cx="8081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15</a:t>
            </a:r>
            <a:r>
              <a:rPr lang="zh-CN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25</a:t>
            </a:r>
            <a:r>
              <a:rPr lang="zh-CN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35</a:t>
            </a:r>
            <a:r>
              <a:rPr lang="zh-CN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9872" y="3254364"/>
            <a:ext cx="2592287" cy="1933447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9445" y="3241610"/>
            <a:ext cx="2510180" cy="1872208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9872" y="746355"/>
            <a:ext cx="2489031" cy="1856434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2200" y="769306"/>
            <a:ext cx="2453109" cy="1829642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827585" y="5733256"/>
            <a:ext cx="74888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pollen germination of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two varieties (</a:t>
            </a:r>
            <a:r>
              <a:rPr lang="en-US" altLang="zh-CN" kern="100" dirty="0">
                <a:solidFill>
                  <a:srgbClr val="000000"/>
                </a:solidFill>
                <a:latin typeface="Times New Roman"/>
                <a:ea typeface="等线"/>
              </a:rPr>
              <a:t>‘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/>
                <a:ea typeface="等线"/>
              </a:rPr>
              <a:t>Renong</a:t>
            </a:r>
            <a:r>
              <a:rPr lang="en-US" altLang="zh-CN" kern="100" dirty="0">
                <a:solidFill>
                  <a:srgbClr val="000000"/>
                </a:solidFill>
                <a:latin typeface="Times New Roman"/>
                <a:ea typeface="等线"/>
              </a:rPr>
              <a:t> No.1’ and ‘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/>
                <a:ea typeface="等线"/>
              </a:rPr>
              <a:t>Jinhuang</a:t>
            </a:r>
            <a:r>
              <a:rPr lang="en-US" altLang="zh-CN" kern="100" dirty="0">
                <a:solidFill>
                  <a:srgbClr val="000000"/>
                </a:solidFill>
                <a:latin typeface="Times New Roman"/>
                <a:ea typeface="等线"/>
              </a:rPr>
              <a:t>’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)        under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15℃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25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℃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nd35</a:t>
            </a:r>
            <a:r>
              <a:rPr lang="en-US" altLang="zh-CN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℃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temperature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tress respectively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0468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37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6</cp:revision>
  <dcterms:created xsi:type="dcterms:W3CDTF">2022-12-12T02:58:24Z</dcterms:created>
  <dcterms:modified xsi:type="dcterms:W3CDTF">2024-10-06T12:37:51Z</dcterms:modified>
</cp:coreProperties>
</file>